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AA066-9CE4-479E-B640-F4151B3A84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09AC4-3A29-48AB-BA08-9C4B0AB953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8F697-C1D2-4BCA-8318-B5F0874835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42DA1-D25B-426F-84B4-B041FE620E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9DE18-6568-4E0D-B629-7EB22251D0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2A7B9-9F3E-41B7-9ABB-373B638D69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31D3D-CC7E-45A8-BE0E-0CB5E741E4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B55A8-27F5-4D2D-A14B-555C00D865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2587F-2F8A-4FA0-98DF-192A50DCAB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C3CA6-A760-42C1-A920-845C90DE6B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55163-F11F-485B-A675-6EB079A65C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E79E7-4137-4FB5-8B68-4DD6733BBC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080BAD-2390-485C-A11F-9B81EFB03A6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41360" y="549360"/>
            <a:ext cx="8197920" cy="41450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66680" y="4937040"/>
            <a:ext cx="853920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6000"/>
          </a:bodyPr>
          <a:p>
            <a:pPr marL="329040" indent="-329040" algn="just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5. Nrf2 pathway regulation by SF and tBHQ in RR and RS cells (short film exposure)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8 h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A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and 16 h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B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treatment with 5 μM SF or 10 μM tBHQ activated Nrf2 pathway to a similar extent in both CRI-G1-RR and RS cells. Statistical significance was determined by two-way ANOVA; data are plotted as mean ± S.E.M (n=5). While there was no statistically significant difference between the two cell types overall, ad-hoc Bonferroni post-test detected a statistically significant difference between SF- and tBHQ-induced responses for 16 h treatment in both cell types.  *, p &lt; 0.05; **, p &lt; 0.01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"/>
          <p:cNvSpPr/>
          <p:nvPr/>
        </p:nvSpPr>
        <p:spPr>
          <a:xfrm>
            <a:off x="221040" y="309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"/>
          <p:cNvSpPr/>
          <p:nvPr/>
        </p:nvSpPr>
        <p:spPr>
          <a:xfrm>
            <a:off x="4697640" y="309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2T22:40:32Z</dcterms:created>
  <dc:creator>NChandiramani</dc:creator>
  <dc:description/>
  <dc:language>en-US</dc:language>
  <cp:lastModifiedBy>Christine Lin</cp:lastModifiedBy>
  <dcterms:modified xsi:type="dcterms:W3CDTF">2010-07-06T20:30:57Z</dcterms:modified>
  <cp:revision>80</cp:revision>
  <dc:subject/>
  <dc:title>Slide 1</dc:title>
</cp:coreProperties>
</file>